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6D15BB-8DA7-4B9B-A221-39DEA6DBF3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B21905-80A4-4731-9098-AA8E4B9506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81C341-ADC8-4B1D-8160-E03B2D1654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17247-C0BC-46D5-B4B3-1C98ABDE30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DFE6EA-BB68-4C84-92D2-19159EEFD0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4E3744-EF18-4D68-A4D1-B7C561F6ED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80F59A-AEA6-4B8C-B0D5-9F73657855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EA8535-C5C5-4FB5-9A7D-5F1BB696CC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2002FD-2BDD-4980-8916-F7BB5717AE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209F2-20F8-4763-9C4C-295E87A31B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F6F604-1802-4F66-916F-3CC734369F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49D99-2BE6-44EF-8839-A55FD4CACF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674628-7473-404E-A7FA-17BC4E7D276C}" type="slidenum">
              <a:rPr b="0" lang="en-AU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1785960" y="2286000"/>
            <a:ext cx="5751360" cy="1927080"/>
            <a:chOff x="1785960" y="2286000"/>
            <a:chExt cx="5751360" cy="192708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rcRect l="62410" t="0" r="6774" b="0"/>
            <a:stretch/>
          </p:blipFill>
          <p:spPr>
            <a:xfrm>
              <a:off x="3160080" y="2320200"/>
              <a:ext cx="2766240" cy="72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3" descr=""/>
            <p:cNvPicPr/>
            <p:nvPr/>
          </p:nvPicPr>
          <p:blipFill>
            <a:blip r:embed="rId2"/>
            <a:srcRect l="67296" t="0" r="1252" b="0"/>
            <a:stretch/>
          </p:blipFill>
          <p:spPr>
            <a:xfrm>
              <a:off x="3160080" y="2930400"/>
              <a:ext cx="2766240" cy="873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 Box 25"/>
            <p:cNvSpPr/>
            <p:nvPr/>
          </p:nvSpPr>
          <p:spPr>
            <a:xfrm>
              <a:off x="6146280" y="2455200"/>
              <a:ext cx="1391040" cy="6919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</a:rPr>
                <a:t>50 kD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26"/>
            <p:cNvSpPr/>
            <p:nvPr/>
          </p:nvSpPr>
          <p:spPr>
            <a:xfrm>
              <a:off x="5990400" y="3259800"/>
              <a:ext cx="1085040" cy="6001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</a:rPr>
                <a:t>42 kD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31"/>
            <p:cNvSpPr/>
            <p:nvPr/>
          </p:nvSpPr>
          <p:spPr>
            <a:xfrm flipH="1">
              <a:off x="5926680" y="2611440"/>
              <a:ext cx="248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27"/>
            <p:cNvSpPr/>
            <p:nvPr/>
          </p:nvSpPr>
          <p:spPr>
            <a:xfrm>
              <a:off x="1860840" y="2286000"/>
              <a:ext cx="1185480" cy="4366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</a:rPr>
                <a:t>sFRP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28"/>
            <p:cNvSpPr/>
            <p:nvPr/>
          </p:nvSpPr>
          <p:spPr>
            <a:xfrm>
              <a:off x="1785960" y="3069360"/>
              <a:ext cx="1317240" cy="5824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</a:rPr>
                <a:t>β-Actin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80"/>
            <p:cNvSpPr/>
            <p:nvPr/>
          </p:nvSpPr>
          <p:spPr>
            <a:xfrm>
              <a:off x="3153240" y="3521880"/>
              <a:ext cx="716040" cy="6562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</a:rPr>
                <a:t>IOS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82"/>
            <p:cNvSpPr/>
            <p:nvPr/>
          </p:nvSpPr>
          <p:spPr>
            <a:xfrm>
              <a:off x="4476960" y="3526920"/>
              <a:ext cx="855720" cy="6598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</a:rPr>
                <a:t>AD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83"/>
            <p:cNvSpPr/>
            <p:nvPr/>
          </p:nvSpPr>
          <p:spPr>
            <a:xfrm>
              <a:off x="5191920" y="3571560"/>
              <a:ext cx="761760" cy="6415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</a:rPr>
                <a:t>C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81"/>
            <p:cNvSpPr/>
            <p:nvPr/>
          </p:nvSpPr>
          <p:spPr>
            <a:xfrm>
              <a:off x="3848400" y="3535200"/>
              <a:ext cx="750960" cy="6526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</a:rPr>
                <a:t>A278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30"/>
            <p:cNvSpPr/>
            <p:nvPr/>
          </p:nvSpPr>
          <p:spPr>
            <a:xfrm flipH="1">
              <a:off x="5926320" y="3422880"/>
              <a:ext cx="248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Textfeld 14"/>
          <p:cNvSpPr/>
          <p:nvPr/>
        </p:nvSpPr>
        <p:spPr>
          <a:xfrm>
            <a:off x="1714680" y="5214960"/>
            <a:ext cx="65005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</a:rPr>
              <a:t>A representative image of a Western blot showing sFRP4 protein expression across the four cell lin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feld 15"/>
          <p:cNvSpPr/>
          <p:nvPr/>
        </p:nvSpPr>
        <p:spPr>
          <a:xfrm>
            <a:off x="714240" y="500040"/>
            <a:ext cx="314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Supplementary Fig.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6T20:45:24Z</dcterms:created>
  <dc:creator>User</dc:creator>
  <dc:description/>
  <dc:language>en-US</dc:language>
  <cp:lastModifiedBy>arfuso</cp:lastModifiedBy>
  <dcterms:modified xsi:type="dcterms:W3CDTF">2011-11-28T08:14:06Z</dcterms:modified>
  <cp:revision>2</cp:revision>
  <dc:subject/>
  <dc:title>Slide 1</dc:title>
</cp:coreProperties>
</file>